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8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OHI-FSI\VOLI\Home\LARG\MCPHERSON\Sebastien\Results%202019\MARCH%2025%202019%20SE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0805448979318998E-2"/>
          <c:y val="2.3300455398602163E-2"/>
          <c:w val="0.8842935889380551"/>
          <c:h val="0.63719048549897539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TALLY!$H$38</c:f>
              <c:strCache>
                <c:ptCount val="1"/>
                <c:pt idx="0">
                  <c:v>SRP14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LLY!$K$39:$K$56</c:f>
                <c:numCache>
                  <c:formatCode>General</c:formatCode>
                  <c:ptCount val="18"/>
                  <c:pt idx="0">
                    <c:v>0.30722716878201173</c:v>
                  </c:pt>
                  <c:pt idx="1">
                    <c:v>0.20665953907224424</c:v>
                  </c:pt>
                  <c:pt idx="2">
                    <c:v>8.2577787838437625E-2</c:v>
                  </c:pt>
                  <c:pt idx="3">
                    <c:v>0.25764275327459957</c:v>
                  </c:pt>
                  <c:pt idx="4">
                    <c:v>9.219377963663504E-2</c:v>
                  </c:pt>
                  <c:pt idx="6">
                    <c:v>0.16756859842281854</c:v>
                  </c:pt>
                  <c:pt idx="7">
                    <c:v>4.7689095599775015E-2</c:v>
                  </c:pt>
                  <c:pt idx="8">
                    <c:v>5.321127305539828E-2</c:v>
                  </c:pt>
                  <c:pt idx="9">
                    <c:v>6.5622768987211616E-2</c:v>
                  </c:pt>
                  <c:pt idx="10">
                    <c:v>0.12754621521288925</c:v>
                  </c:pt>
                  <c:pt idx="12">
                    <c:v>0.19881322668375653</c:v>
                  </c:pt>
                  <c:pt idx="13">
                    <c:v>0.1812740449961471</c:v>
                  </c:pt>
                  <c:pt idx="14">
                    <c:v>0.12965634464209147</c:v>
                  </c:pt>
                  <c:pt idx="15">
                    <c:v>8.8365017180749433E-2</c:v>
                  </c:pt>
                  <c:pt idx="16">
                    <c:v>6.9263452620379043E-2</c:v>
                  </c:pt>
                </c:numCache>
              </c:numRef>
            </c:plus>
            <c:minus>
              <c:numRef>
                <c:f>TALLY!$K$39:$K$56</c:f>
                <c:numCache>
                  <c:formatCode>General</c:formatCode>
                  <c:ptCount val="18"/>
                  <c:pt idx="0">
                    <c:v>0.30722716878201173</c:v>
                  </c:pt>
                  <c:pt idx="1">
                    <c:v>0.20665953907224424</c:v>
                  </c:pt>
                  <c:pt idx="2">
                    <c:v>8.2577787838437625E-2</c:v>
                  </c:pt>
                  <c:pt idx="3">
                    <c:v>0.25764275327459957</c:v>
                  </c:pt>
                  <c:pt idx="4">
                    <c:v>9.219377963663504E-2</c:v>
                  </c:pt>
                  <c:pt idx="6">
                    <c:v>0.16756859842281854</c:v>
                  </c:pt>
                  <c:pt idx="7">
                    <c:v>4.7689095599775015E-2</c:v>
                  </c:pt>
                  <c:pt idx="8">
                    <c:v>5.321127305539828E-2</c:v>
                  </c:pt>
                  <c:pt idx="9">
                    <c:v>6.5622768987211616E-2</c:v>
                  </c:pt>
                  <c:pt idx="10">
                    <c:v>0.12754621521288925</c:v>
                  </c:pt>
                  <c:pt idx="12">
                    <c:v>0.19881322668375653</c:v>
                  </c:pt>
                  <c:pt idx="13">
                    <c:v>0.1812740449961471</c:v>
                  </c:pt>
                  <c:pt idx="14">
                    <c:v>0.12965634464209147</c:v>
                  </c:pt>
                  <c:pt idx="15">
                    <c:v>8.8365017180749433E-2</c:v>
                  </c:pt>
                  <c:pt idx="16">
                    <c:v>6.92634526203790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TALLY!$E$39:$F$56</c:f>
              <c:multiLvlStrCache>
                <c:ptCount val="18"/>
                <c:lvl>
                  <c:pt idx="0">
                    <c:v>Wortmannin</c:v>
                  </c:pt>
                  <c:pt idx="1">
                    <c:v>PD98059</c:v>
                  </c:pt>
                  <c:pt idx="2">
                    <c:v>SB203580</c:v>
                  </c:pt>
                  <c:pt idx="3">
                    <c:v>SP600125</c:v>
                  </c:pt>
                  <c:pt idx="4">
                    <c:v>TCPA1</c:v>
                  </c:pt>
                  <c:pt idx="5">
                    <c:v>Vehicle</c:v>
                  </c:pt>
                  <c:pt idx="6">
                    <c:v>Wortmannin</c:v>
                  </c:pt>
                  <c:pt idx="7">
                    <c:v>PD98059</c:v>
                  </c:pt>
                  <c:pt idx="8">
                    <c:v>SB203580</c:v>
                  </c:pt>
                  <c:pt idx="9">
                    <c:v>SP600125</c:v>
                  </c:pt>
                  <c:pt idx="10">
                    <c:v>TCPA1</c:v>
                  </c:pt>
                  <c:pt idx="11">
                    <c:v>Vehicle</c:v>
                  </c:pt>
                  <c:pt idx="12">
                    <c:v>Wortmannin</c:v>
                  </c:pt>
                  <c:pt idx="13">
                    <c:v>PD98059</c:v>
                  </c:pt>
                  <c:pt idx="14">
                    <c:v>SB203580</c:v>
                  </c:pt>
                  <c:pt idx="15">
                    <c:v>SP600125</c:v>
                  </c:pt>
                  <c:pt idx="16">
                    <c:v>TCPA1</c:v>
                  </c:pt>
                  <c:pt idx="17">
                    <c:v>Vehicle</c:v>
                  </c:pt>
                </c:lvl>
                <c:lvl>
                  <c:pt idx="0">
                    <c:v>trcrRNA</c:v>
                  </c:pt>
                  <c:pt idx="6">
                    <c:v>SG-505</c:v>
                  </c:pt>
                  <c:pt idx="12">
                    <c:v>SG-286</c:v>
                  </c:pt>
                </c:lvl>
              </c:multiLvlStrCache>
            </c:multiLvlStrRef>
          </c:cat>
          <c:val>
            <c:numRef>
              <c:f>TALLY!$H$39:$H$56</c:f>
              <c:numCache>
                <c:formatCode>General</c:formatCode>
                <c:ptCount val="18"/>
                <c:pt idx="0">
                  <c:v>0.98026134782390573</c:v>
                </c:pt>
                <c:pt idx="1">
                  <c:v>1.0285432667082344</c:v>
                </c:pt>
                <c:pt idx="2">
                  <c:v>0.93082618819412166</c:v>
                </c:pt>
                <c:pt idx="3">
                  <c:v>0.87552702403490168</c:v>
                </c:pt>
                <c:pt idx="4">
                  <c:v>1.0615308880019414</c:v>
                </c:pt>
                <c:pt idx="5">
                  <c:v>1</c:v>
                </c:pt>
                <c:pt idx="6">
                  <c:v>1.1872962317082418</c:v>
                </c:pt>
                <c:pt idx="7">
                  <c:v>1.0213245886723785</c:v>
                </c:pt>
                <c:pt idx="8">
                  <c:v>0.98716733641671084</c:v>
                </c:pt>
                <c:pt idx="9">
                  <c:v>0.88937751156266587</c:v>
                </c:pt>
                <c:pt idx="10">
                  <c:v>1.0213814542421715</c:v>
                </c:pt>
                <c:pt idx="11">
                  <c:v>1</c:v>
                </c:pt>
                <c:pt idx="12">
                  <c:v>0.95589339913582538</c:v>
                </c:pt>
                <c:pt idx="13">
                  <c:v>0.99148674497504741</c:v>
                </c:pt>
                <c:pt idx="14">
                  <c:v>0.9398700533356813</c:v>
                </c:pt>
                <c:pt idx="15">
                  <c:v>0.9061964757506612</c:v>
                </c:pt>
                <c:pt idx="16">
                  <c:v>1.124599199215558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86-4865-A67A-2D6679D84B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31924912"/>
        <c:axId val="431923272"/>
      </c:barChart>
      <c:catAx>
        <c:axId val="431924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31923272"/>
        <c:crosses val="autoZero"/>
        <c:auto val="1"/>
        <c:lblAlgn val="ctr"/>
        <c:lblOffset val="100"/>
        <c:noMultiLvlLbl val="0"/>
      </c:catAx>
      <c:valAx>
        <c:axId val="431923272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31924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8811313"/>
              </p:ext>
            </p:extLst>
          </p:nvPr>
        </p:nvGraphicFramePr>
        <p:xfrm>
          <a:off x="2214563" y="538162"/>
          <a:ext cx="4738688" cy="4167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121126" y="1791952"/>
            <a:ext cx="35964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elative expression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Vehcil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=1)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304926" y="5343525"/>
            <a:ext cx="63246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auto">
              <a:spcAft>
                <a:spcPts val="1000"/>
              </a:spcAft>
            </a:pPr>
            <a:r>
              <a:rPr lang="en-CA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5 Fig. </a:t>
            </a:r>
            <a:r>
              <a:rPr lang="en-US" sz="1400" b="1" kern="15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inase inhibitors </a:t>
            </a:r>
            <a:r>
              <a:rPr lang="en-US" sz="1400" b="1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o not affect SRP14.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Specificity control for Fig. 8; see Figure 8 for additional information.    Levels of SRP14 were measured in 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ISPRa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ransfected cells (in the presence of SG-505, SG-286 or 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crRNA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nd normalized to the matching vehicle (0.1% DMSO) </a:t>
            </a:r>
            <a:r>
              <a:rPr lang="en-US" sz="1400" kern="15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ISPRa</a:t>
            </a:r>
            <a:r>
              <a:rPr lang="en-US" sz="1400" kern="15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ample.  Data represent </a:t>
            </a:r>
            <a:r>
              <a:rPr lang="en-US" sz="1400" kern="15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average of 3 experiments (± S.D.). </a:t>
            </a:r>
            <a:endParaRPr lang="en-CA" sz="1400" kern="15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264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7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8:43Z</dcterms:modified>
</cp:coreProperties>
</file>